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71" r:id="rId4"/>
    <p:sldId id="272" r:id="rId5"/>
    <p:sldId id="273" r:id="rId6"/>
    <p:sldId id="274" r:id="rId7"/>
    <p:sldId id="275" r:id="rId8"/>
    <p:sldId id="276" r:id="rId9"/>
    <p:sldId id="277" r:id="rId10"/>
    <p:sldId id="278" r:id="rId11"/>
    <p:sldId id="279" r:id="rId12"/>
    <p:sldId id="280" r:id="rId13"/>
    <p:sldId id="281" r:id="rId14"/>
    <p:sldId id="282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汤 臻" initials="汤" lastIdx="1" clrIdx="0">
    <p:extLst>
      <p:ext uri="{19B8F6BF-5375-455C-9EA6-DF929625EA0E}">
        <p15:presenceInfo xmlns:p15="http://schemas.microsoft.com/office/powerpoint/2012/main" userId="1e11062194281df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FD473F-0EA7-4048-BCC2-00CF318D9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7C153CE-20DD-4A0F-8E27-CB95194DFC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78EDD-E497-47E8-9FBD-C54BDF02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CF8432-8FD1-4452-8E70-256A06FFD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8A10B0-A565-473B-924C-62413C79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940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945473-7259-4455-9BFA-5F915AA51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499EB8-B61D-4AAC-A153-090825DAF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DB4AE3-F928-4A00-931E-D57FFF0DD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20E740-A4BB-40DA-9A59-4298C875B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5AD836-D4F0-4EFD-A086-8DD0D0694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1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173354-FBF7-4692-B2B7-D6683F6260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F8104A-EBC0-495E-9533-3594B9EF6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F3BCC8-32C9-4F15-BA33-D213F9AE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A0008F-80A6-4AC4-ABED-D4F9B96B4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38F60E-526A-469C-8D14-44694323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56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66B3D-0B3F-4843-A875-678A2110D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80E5D2-5E13-4FE3-A451-18266FC1B5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C6EE60-68CF-4F4F-B7D8-621F3D92E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F9D512-5FA0-44E4-80EF-926B1430B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DB6FBF-6030-4EC0-898C-D0DF283E1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09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B56802-0183-4413-8018-31C80673B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D17DEE-F3D3-4E32-9158-B2E160352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0FBD28-589E-4774-92DE-D94C7D966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D09830-E11C-4B08-A590-26DD82095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9BD627-AED3-45AF-97FC-F8D53947C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891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48C37-24EF-41EE-9326-043758BD0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1094FCA-BB2E-4A2A-BAE8-4E796CBCD0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159882-3E00-4D8D-9E2C-DB2801AAC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5B8B05-09F5-42E5-A886-0F178C58A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1BE365-444A-4458-937D-A24C9127A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764B81-FB44-4C0F-BA23-BA76F9F83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564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4E3C12-D745-4CDA-A000-3B5972D72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86AA5E-279F-47E8-83D9-7E54C1665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441AD8-69AC-4038-8F1F-4A4DCBD4B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510166-A194-478D-813C-5E0BB70F2D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324614-EF39-4EF3-9D8A-34FDA74D58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D3B12C6-A17B-4EE9-8463-FC27998F6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E505A5-B4DA-4E70-81BD-508772BB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90285E-1615-4788-8666-2E54F992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466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844695-39B2-4C85-935C-3ABD849BE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9EEAE2-9DFB-43FD-8367-20990D47F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0C2BC2E-7C11-4EF3-860F-2AACD017F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DDD7B43-B994-4FE1-8F81-C18A4478A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486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BFD864F-3F38-4734-A389-C94236A81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23B3865-B1D1-487B-9AB3-11ABED9AA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F66AC4-12DB-46D3-AAF4-83937882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2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7F578-B332-495B-BFCF-E4E674C9B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C7CB70-4E4A-47B5-B41D-BA9848B730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9F588F-A31C-4A0A-9BF1-69AA4297D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F48BFF-20B4-4CDF-9D36-6647FF6A5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0E7488-5931-4311-BC96-B9161F4EE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7C6BA7-A1FC-4CBC-9AD6-55B245641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600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67A7C6-66A8-4100-B5DC-341F984B3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9B0E8C-C09F-4019-9E18-F04157E88D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C3CA89-5526-4B43-87B1-2AF93F684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C4E759-8E46-4F3F-939A-712B7F62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EEE8C7-B4C3-4B0A-969E-3523E933C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D92D64-7956-49FB-A4D5-850B29F50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518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70BB02-B800-480F-BA03-DC8447AD5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48328E-9F0C-4BDC-8EE3-271AD0E91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63930C-7164-45AE-91FA-198AB8307E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11010-BD7C-4C1D-9149-B9AA4901EF11}" type="datetimeFigureOut">
              <a:rPr lang="zh-CN" altLang="en-US" smtClean="0"/>
              <a:t>2021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27118E-7395-40B2-AD62-5E73D281D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DADD65-8135-422F-AF93-A4275AA0B7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255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D</a:t>
            </a:r>
            <a:endParaRPr lang="zh-CN" altLang="en-US" dirty="0"/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644AC91F-C0AC-4C4D-A634-1750BC376DE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8877721"/>
              </p:ext>
            </p:extLst>
          </p:nvPr>
        </p:nvGraphicFramePr>
        <p:xfrm>
          <a:off x="838200" y="4258469"/>
          <a:ext cx="10515600" cy="1180305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134693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50447825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119063894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13447308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693113487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14770352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95447668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2088135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44285050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363711143"/>
                    </a:ext>
                  </a:extLst>
                </a:gridCol>
              </a:tblGrid>
              <a:tr h="393435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9873527"/>
                  </a:ext>
                </a:extLst>
              </a:tr>
              <a:tr h="39343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1.79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0.758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47.519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9.302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2.9726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1.134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4.9212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4.0525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1.1684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634700"/>
                  </a:ext>
                </a:extLst>
              </a:tr>
              <a:tr h="39343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9.8139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9.5338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0.3747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8.135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7.8568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7.8568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.7640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.214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12.865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226552"/>
                  </a:ext>
                </a:extLst>
              </a:tr>
            </a:tbl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C0F11659-B1DE-40B6-BE59-00AF97E795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7686859"/>
              </p:ext>
            </p:extLst>
          </p:nvPr>
        </p:nvGraphicFramePr>
        <p:xfrm>
          <a:off x="4349750" y="1419226"/>
          <a:ext cx="29591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59235" imgH="2795406" progId="Prism8.Document">
                  <p:embed/>
                </p:oleObj>
              </mc:Choice>
              <mc:Fallback>
                <p:oleObj name="Prism 8" r:id="rId2" imgW="2959235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49750" y="1419226"/>
                        <a:ext cx="29591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919786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E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E90D167A-8801-436E-9F8C-E3A663CD68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7377289"/>
              </p:ext>
            </p:extLst>
          </p:nvPr>
        </p:nvGraphicFramePr>
        <p:xfrm>
          <a:off x="3846513" y="935038"/>
          <a:ext cx="324008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239781" imgH="2795406" progId="Prism8.Document">
                  <p:embed/>
                </p:oleObj>
              </mc:Choice>
              <mc:Fallback>
                <p:oleObj name="Prism 8" r:id="rId2" imgW="3239781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46513" y="935038"/>
                        <a:ext cx="324008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6FBFAA4-980D-4150-97D6-E5CEC34FA1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1446550"/>
              </p:ext>
            </p:extLst>
          </p:nvPr>
        </p:nvGraphicFramePr>
        <p:xfrm>
          <a:off x="4143375" y="3807619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400609724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79169812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55520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.32142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.05638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2414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52625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5.381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53707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5.3813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.26116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4600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37946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F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96700F12-9E3D-4B71-9FC6-83CDAAD590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9311602"/>
              </p:ext>
            </p:extLst>
          </p:nvPr>
        </p:nvGraphicFramePr>
        <p:xfrm>
          <a:off x="3700463" y="944563"/>
          <a:ext cx="332263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321892" imgH="2795406" progId="Prism8.Document">
                  <p:embed/>
                </p:oleObj>
              </mc:Choice>
              <mc:Fallback>
                <p:oleObj name="Prism 8" r:id="rId2" imgW="3321892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00463" y="944563"/>
                        <a:ext cx="332263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C9D88DA-3D59-42D7-94D8-41F4FEB0E4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5998747"/>
              </p:ext>
            </p:extLst>
          </p:nvPr>
        </p:nvGraphicFramePr>
        <p:xfrm>
          <a:off x="4029075" y="3988594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177709179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83734224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8309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9.62142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35337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7616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1455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8040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30266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00047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8.65687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92133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114987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26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G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3CC6925D-4C11-41F3-94CE-C62E4E1D04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0461812"/>
              </p:ext>
            </p:extLst>
          </p:nvPr>
        </p:nvGraphicFramePr>
        <p:xfrm>
          <a:off x="3957638" y="1039813"/>
          <a:ext cx="332263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321892" imgH="2795406" progId="Prism8.Document">
                  <p:embed/>
                </p:oleObj>
              </mc:Choice>
              <mc:Fallback>
                <p:oleObj name="Prism 8" r:id="rId2" imgW="3321892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57638" y="1039813"/>
                        <a:ext cx="332263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388CBD4-03AA-411A-A8E1-B17D12C21F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28333"/>
              </p:ext>
            </p:extLst>
          </p:nvPr>
        </p:nvGraphicFramePr>
        <p:xfrm>
          <a:off x="4324350" y="4045744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105221080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7203496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6994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6.3880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7.2104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51344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7.366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4.7583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3069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16.8863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7.3663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9584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89499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H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9B69D365-9095-4AEC-9F7F-960CFC0C62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6830616"/>
              </p:ext>
            </p:extLst>
          </p:nvPr>
        </p:nvGraphicFramePr>
        <p:xfrm>
          <a:off x="4048125" y="1173163"/>
          <a:ext cx="34290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428852" imgH="2795406" progId="Prism8.Document">
                  <p:embed/>
                </p:oleObj>
              </mc:Choice>
              <mc:Fallback>
                <p:oleObj name="Prism 8" r:id="rId2" imgW="3428852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48125" y="1173163"/>
                        <a:ext cx="34290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1A056061-9A5F-4371-AFF3-74E025692B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6574791"/>
              </p:ext>
            </p:extLst>
          </p:nvPr>
        </p:nvGraphicFramePr>
        <p:xfrm>
          <a:off x="4343400" y="4198144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1926418691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82281589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590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05900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06397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23935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0557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5570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9159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0.0540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0623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06373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77484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I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F800EB3A-3DE2-4B84-B192-6ABE7CCF77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0602476"/>
              </p:ext>
            </p:extLst>
          </p:nvPr>
        </p:nvGraphicFramePr>
        <p:xfrm>
          <a:off x="4014788" y="1077913"/>
          <a:ext cx="332263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321892" imgH="2795406" progId="Prism8.Document">
                  <p:embed/>
                </p:oleObj>
              </mc:Choice>
              <mc:Fallback>
                <p:oleObj name="Prism 8" r:id="rId2" imgW="3321892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14788" y="1077913"/>
                        <a:ext cx="332263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C7B46A-464C-4E07-B71A-36D05196F5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1577952"/>
              </p:ext>
            </p:extLst>
          </p:nvPr>
        </p:nvGraphicFramePr>
        <p:xfrm>
          <a:off x="4362450" y="4226719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386103138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177951106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11926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48422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90077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40123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29168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68559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4332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90077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8.0893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55530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511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E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7F95F677-8553-4C97-9479-32B5DB08D9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1047435"/>
              </p:ext>
            </p:extLst>
          </p:nvPr>
        </p:nvGraphicFramePr>
        <p:xfrm>
          <a:off x="4264025" y="1011238"/>
          <a:ext cx="28829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882886" imgH="2795406" progId="Prism8.Document">
                  <p:embed/>
                </p:oleObj>
              </mc:Choice>
              <mc:Fallback>
                <p:oleObj name="Prism 8" r:id="rId2" imgW="2882886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64025" y="1011238"/>
                        <a:ext cx="28829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A32B391C-C53D-4F36-B9B0-54A541FD92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6741928"/>
              </p:ext>
            </p:extLst>
          </p:nvPr>
        </p:nvGraphicFramePr>
        <p:xfrm>
          <a:off x="838200" y="3782218"/>
          <a:ext cx="10515600" cy="1094580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116509328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99386265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68195392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60630838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272933654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93937266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1810315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01302146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271924269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98770052"/>
                    </a:ext>
                  </a:extLst>
                </a:gridCol>
              </a:tblGrid>
              <a:tr h="364860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9353008"/>
                  </a:ext>
                </a:extLst>
              </a:tr>
              <a:tr h="36486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5.5606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5.121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6.2204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.8009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4555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.58281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.05721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83944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18638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374226"/>
                  </a:ext>
                </a:extLst>
              </a:tr>
              <a:tr h="36486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67381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23728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.8009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.71078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.2750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83944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.96878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.53371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3.7512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8862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76164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F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EF548FA4-D967-4F0B-B1D8-3A5B9C5A7B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7043783"/>
              </p:ext>
            </p:extLst>
          </p:nvPr>
        </p:nvGraphicFramePr>
        <p:xfrm>
          <a:off x="4654550" y="1030288"/>
          <a:ext cx="28829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882886" imgH="2795406" progId="Prism8.Document">
                  <p:embed/>
                </p:oleObj>
              </mc:Choice>
              <mc:Fallback>
                <p:oleObj name="Prism 8" r:id="rId2" imgW="2882886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54550" y="1030288"/>
                        <a:ext cx="28829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BDD9FA13-E927-4D78-86D0-357D310CE4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5792338"/>
              </p:ext>
            </p:extLst>
          </p:nvPr>
        </p:nvGraphicFramePr>
        <p:xfrm>
          <a:off x="838200" y="3782219"/>
          <a:ext cx="10515600" cy="1027905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2580777447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58768161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03782452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9315939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17750972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87161589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27169193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79027448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494930324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163658884"/>
                    </a:ext>
                  </a:extLst>
                </a:gridCol>
              </a:tblGrid>
              <a:tr h="342635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66576282"/>
                  </a:ext>
                </a:extLst>
              </a:tr>
              <a:tr h="34263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1560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.62641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68568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9.53867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8.74465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0.0679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77193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50693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4.77193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035901"/>
                  </a:ext>
                </a:extLst>
              </a:tr>
              <a:tr h="34263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9.00934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8.74465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9.27402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6.6770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14.8277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5.0919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.0966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.83175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5.56682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44471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77708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G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87FFE36E-277E-46B3-939D-CC52DC012E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557621"/>
              </p:ext>
            </p:extLst>
          </p:nvPr>
        </p:nvGraphicFramePr>
        <p:xfrm>
          <a:off x="4359275" y="849313"/>
          <a:ext cx="29591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59235" imgH="2795406" progId="Prism8.Document">
                  <p:embed/>
                </p:oleObj>
              </mc:Choice>
              <mc:Fallback>
                <p:oleObj name="Prism 8" r:id="rId2" imgW="2959235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59275" y="849313"/>
                        <a:ext cx="29591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DD92C8C5-D945-453C-9BF6-268E1ABB60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234088"/>
              </p:ext>
            </p:extLst>
          </p:nvPr>
        </p:nvGraphicFramePr>
        <p:xfrm>
          <a:off x="838200" y="3782219"/>
          <a:ext cx="10515600" cy="1085055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369933349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39756387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98822206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44497937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35673896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85035351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18756063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410088114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09124286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749043141"/>
                    </a:ext>
                  </a:extLst>
                </a:gridCol>
              </a:tblGrid>
              <a:tr h="361685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6584325"/>
                  </a:ext>
                </a:extLst>
              </a:tr>
              <a:tr h="3616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6.1828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3.723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1.5314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6.1149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9.8648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6.5570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.8430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2.7109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.110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861407"/>
                  </a:ext>
                </a:extLst>
              </a:tr>
              <a:tr h="3616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24.105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2.076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6.010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04.739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38.506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35.140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3.845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53.9615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58.3014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4994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947992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H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35ECF714-581C-4DF2-8B4E-E4AC37A301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0804377"/>
              </p:ext>
            </p:extLst>
          </p:nvPr>
        </p:nvGraphicFramePr>
        <p:xfrm>
          <a:off x="4492625" y="915988"/>
          <a:ext cx="29591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59235" imgH="2795406" progId="Prism8.Document">
                  <p:embed/>
                </p:oleObj>
              </mc:Choice>
              <mc:Fallback>
                <p:oleObj name="Prism 8" r:id="rId2" imgW="2959235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92625" y="915988"/>
                        <a:ext cx="29591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6611BEC6-ECD4-453D-AE9D-0B22DC1DC1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5927408"/>
              </p:ext>
            </p:extLst>
          </p:nvPr>
        </p:nvGraphicFramePr>
        <p:xfrm>
          <a:off x="838200" y="3782218"/>
          <a:ext cx="10515600" cy="1043781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92970671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188060357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713892087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01299756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42038827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61737449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63290829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61626712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93538379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7030250"/>
                    </a:ext>
                  </a:extLst>
                </a:gridCol>
              </a:tblGrid>
              <a:tr h="347927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64681975"/>
                  </a:ext>
                </a:extLst>
              </a:tr>
              <a:tr h="34792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56.23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53.023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29.172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1.657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3.748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3.051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29.997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6.042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4.362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898953"/>
                  </a:ext>
                </a:extLst>
              </a:tr>
              <a:tr h="34792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20.087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51.219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2.702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52.890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46.815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45.130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0.9348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67.5125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64.2220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04613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6839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I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D94C365A-FB65-4B7D-AC52-0FC64196E1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762712"/>
              </p:ext>
            </p:extLst>
          </p:nvPr>
        </p:nvGraphicFramePr>
        <p:xfrm>
          <a:off x="4416425" y="633413"/>
          <a:ext cx="29210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21061" imgH="2795406" progId="Prism8.Document">
                  <p:embed/>
                </p:oleObj>
              </mc:Choice>
              <mc:Fallback>
                <p:oleObj name="Prism 8" r:id="rId2" imgW="2921061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16425" y="633413"/>
                        <a:ext cx="29210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D237A87-A3BA-4B83-B778-B2BDF5E7E3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8262412"/>
              </p:ext>
            </p:extLst>
          </p:nvPr>
        </p:nvGraphicFramePr>
        <p:xfrm>
          <a:off x="838200" y="3782218"/>
          <a:ext cx="10515600" cy="1170780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68291516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45376379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16798245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72828629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1602846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84366868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77545720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961822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86474868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57328622"/>
                    </a:ext>
                  </a:extLst>
                </a:gridCol>
              </a:tblGrid>
              <a:tr h="390260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7120467"/>
                  </a:ext>
                </a:extLst>
              </a:tr>
              <a:tr h="39026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13605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15990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153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23777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26414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22902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08224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09561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09561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7747006"/>
                  </a:ext>
                </a:extLst>
              </a:tr>
              <a:tr h="39026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34453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296074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31215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62804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64170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5738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1242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0.13775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0.12082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60200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29418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J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152889A9-A6EB-4EC0-8EA1-2B7BD84A52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2088139"/>
              </p:ext>
            </p:extLst>
          </p:nvPr>
        </p:nvGraphicFramePr>
        <p:xfrm>
          <a:off x="4378325" y="887413"/>
          <a:ext cx="2882900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882886" imgH="2795406" progId="Prism8.Document">
                  <p:embed/>
                </p:oleObj>
              </mc:Choice>
              <mc:Fallback>
                <p:oleObj name="Prism 8" r:id="rId2" imgW="2882886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78325" y="887413"/>
                        <a:ext cx="2882900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50F202D7-3A99-4FB6-90A1-CD97BA4EE8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30186134"/>
              </p:ext>
            </p:extLst>
          </p:nvPr>
        </p:nvGraphicFramePr>
        <p:xfrm>
          <a:off x="838200" y="3782219"/>
          <a:ext cx="10515600" cy="1085055"/>
        </p:xfrm>
        <a:graphic>
          <a:graphicData uri="http://schemas.openxmlformats.org/drawingml/2006/table">
            <a:tbl>
              <a:tblPr/>
              <a:tblGrid>
                <a:gridCol w="1051560">
                  <a:extLst>
                    <a:ext uri="{9D8B030D-6E8A-4147-A177-3AD203B41FA5}">
                      <a16:colId xmlns:a16="http://schemas.microsoft.com/office/drawing/2014/main" val="386923129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168909336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409899129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205277341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335955565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2771920533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487457550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839166952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336136447"/>
                    </a:ext>
                  </a:extLst>
                </a:gridCol>
                <a:gridCol w="1051560">
                  <a:extLst>
                    <a:ext uri="{9D8B030D-6E8A-4147-A177-3AD203B41FA5}">
                      <a16:colId xmlns:a16="http://schemas.microsoft.com/office/drawing/2014/main" val="1359709158"/>
                    </a:ext>
                  </a:extLst>
                </a:gridCol>
              </a:tblGrid>
              <a:tr h="361685">
                <a:tc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6Al4V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Ti244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Con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6080954"/>
                  </a:ext>
                </a:extLst>
              </a:tr>
              <a:tr h="3616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3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0.7460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9.92260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.3671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4.94346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3.459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6.0136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8.29168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082502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7.68559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958626"/>
                  </a:ext>
                </a:extLst>
              </a:tr>
              <a:tr h="36168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effectLst/>
                          <a:latin typeface="Arial" panose="020B0604020202020204" pitchFamily="34" charset="0"/>
                        </a:rPr>
                        <a:t>7 day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2.4090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2.82809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1.78291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.4810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30.44863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26.7118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9.922605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>
                          <a:effectLst/>
                          <a:latin typeface="Arial" panose="020B0604020202020204" pitchFamily="34" charset="0"/>
                        </a:rPr>
                        <a:t>10.1279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900" b="0" i="0" u="none" strike="noStrike" dirty="0">
                          <a:effectLst/>
                          <a:latin typeface="Arial" panose="020B0604020202020204" pitchFamily="34" charset="0"/>
                        </a:rPr>
                        <a:t>10.95277</a:t>
                      </a:r>
                    </a:p>
                  </a:txBody>
                  <a:tcPr marL="5842" marR="5842" marT="584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0207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5936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C</a:t>
            </a:r>
            <a:endParaRPr lang="zh-CN" altLang="en-US" dirty="0"/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CD154314-AC64-4026-B315-311C0D83C6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3761881"/>
              </p:ext>
            </p:extLst>
          </p:nvPr>
        </p:nvGraphicFramePr>
        <p:xfrm>
          <a:off x="4081463" y="1001713"/>
          <a:ext cx="332263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321892" imgH="2795406" progId="Prism8.Document">
                  <p:embed/>
                </p:oleObj>
              </mc:Choice>
              <mc:Fallback>
                <p:oleObj name="Prism 8" r:id="rId2" imgW="3321892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81463" y="1001713"/>
                        <a:ext cx="332263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A098623E-BBB5-40C1-AFD6-5528ACB07B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3752704"/>
              </p:ext>
            </p:extLst>
          </p:nvPr>
        </p:nvGraphicFramePr>
        <p:xfrm>
          <a:off x="4457700" y="4093369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99606576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98437823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083720"/>
                  </a:ext>
                </a:extLst>
              </a:tr>
              <a:tr h="75406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6603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3881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01192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66031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8.47778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25011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7.93262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7.38819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49255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5736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30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D</a:t>
            </a:r>
            <a:endParaRPr lang="zh-CN" altLang="en-US" dirty="0"/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26276DF7-B97A-426B-9C46-C58527E91F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2637441"/>
              </p:ext>
            </p:extLst>
          </p:nvPr>
        </p:nvGraphicFramePr>
        <p:xfrm>
          <a:off x="4132263" y="839788"/>
          <a:ext cx="3240087" cy="279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239781" imgH="2795406" progId="Prism8.Document">
                  <p:embed/>
                </p:oleObj>
              </mc:Choice>
              <mc:Fallback>
                <p:oleObj name="Prism 8" r:id="rId2" imgW="3239781" imgH="279540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32263" y="839788"/>
                        <a:ext cx="3240087" cy="279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C5F5C70-77A9-4C05-91F4-671C93E6D7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03010"/>
              </p:ext>
            </p:extLst>
          </p:nvPr>
        </p:nvGraphicFramePr>
        <p:xfrm>
          <a:off x="4391025" y="4026694"/>
          <a:ext cx="2286000" cy="635000"/>
        </p:xfrm>
        <a:graphic>
          <a:graphicData uri="http://schemas.openxmlformats.org/drawingml/2006/table">
            <a:tbl>
              <a:tblPr/>
              <a:tblGrid>
                <a:gridCol w="1143000">
                  <a:extLst>
                    <a:ext uri="{9D8B030D-6E8A-4147-A177-3AD203B41FA5}">
                      <a16:colId xmlns:a16="http://schemas.microsoft.com/office/drawing/2014/main" val="3956553333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264570785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6Al4V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MD-Ti244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993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7512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9687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4243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5337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3.53371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1844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>
                          <a:effectLst/>
                          <a:latin typeface="Arial" panose="020B0604020202020204" pitchFamily="34" charset="0"/>
                        </a:rPr>
                        <a:t>4.40402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1000" b="0" i="0" u="none" strike="noStrike" dirty="0">
                          <a:effectLst/>
                          <a:latin typeface="Arial" panose="020B0604020202020204" pitchFamily="34" charset="0"/>
                        </a:rPr>
                        <a:t>3.96878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0218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6579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</TotalTime>
  <Words>273</Words>
  <Application>Microsoft Office PowerPoint</Application>
  <PresentationFormat>宽屏</PresentationFormat>
  <Paragraphs>231</Paragraphs>
  <Slides>1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9" baseType="lpstr">
      <vt:lpstr>等线</vt:lpstr>
      <vt:lpstr>等线 Light</vt:lpstr>
      <vt:lpstr>Arial</vt:lpstr>
      <vt:lpstr>Office 主题​​</vt:lpstr>
      <vt:lpstr>GraphPad Prism 8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14</cp:revision>
  <dcterms:created xsi:type="dcterms:W3CDTF">2021-07-29T08:45:17Z</dcterms:created>
  <dcterms:modified xsi:type="dcterms:W3CDTF">2021-07-30T04:27:04Z</dcterms:modified>
</cp:coreProperties>
</file>